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napToGrid="0" showGuides="1">
      <p:cViewPr varScale="1">
        <p:scale>
          <a:sx n="70" d="100"/>
          <a:sy n="70" d="100"/>
        </p:scale>
        <p:origin x="-1350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0DAB9-A680-476A-AF99-ED613F95F723}" type="datetimeFigureOut">
              <a:rPr lang="fr-FR" smtClean="0"/>
              <a:t>15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B116C-CEBA-4659-B1C5-A966FD5EDD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5908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0DAB9-A680-476A-AF99-ED613F95F723}" type="datetimeFigureOut">
              <a:rPr lang="fr-FR" smtClean="0"/>
              <a:t>15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B116C-CEBA-4659-B1C5-A966FD5EDD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51121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0DAB9-A680-476A-AF99-ED613F95F723}" type="datetimeFigureOut">
              <a:rPr lang="fr-FR" smtClean="0"/>
              <a:t>15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B116C-CEBA-4659-B1C5-A966FD5EDD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29246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0DAB9-A680-476A-AF99-ED613F95F723}" type="datetimeFigureOut">
              <a:rPr lang="fr-FR" smtClean="0"/>
              <a:t>15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B116C-CEBA-4659-B1C5-A966FD5EDD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95833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0DAB9-A680-476A-AF99-ED613F95F723}" type="datetimeFigureOut">
              <a:rPr lang="fr-FR" smtClean="0"/>
              <a:t>15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B116C-CEBA-4659-B1C5-A966FD5EDD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69803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0DAB9-A680-476A-AF99-ED613F95F723}" type="datetimeFigureOut">
              <a:rPr lang="fr-FR" smtClean="0"/>
              <a:t>15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B116C-CEBA-4659-B1C5-A966FD5EDD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25634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0DAB9-A680-476A-AF99-ED613F95F723}" type="datetimeFigureOut">
              <a:rPr lang="fr-FR" smtClean="0"/>
              <a:t>15/05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B116C-CEBA-4659-B1C5-A966FD5EDD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8591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0DAB9-A680-476A-AF99-ED613F95F723}" type="datetimeFigureOut">
              <a:rPr lang="fr-FR" smtClean="0"/>
              <a:t>15/05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B116C-CEBA-4659-B1C5-A966FD5EDD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82311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0DAB9-A680-476A-AF99-ED613F95F723}" type="datetimeFigureOut">
              <a:rPr lang="fr-FR" smtClean="0"/>
              <a:t>15/05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B116C-CEBA-4659-B1C5-A966FD5EDD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92731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0DAB9-A680-476A-AF99-ED613F95F723}" type="datetimeFigureOut">
              <a:rPr lang="fr-FR" smtClean="0"/>
              <a:t>15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B116C-CEBA-4659-B1C5-A966FD5EDD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82598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0DAB9-A680-476A-AF99-ED613F95F723}" type="datetimeFigureOut">
              <a:rPr lang="fr-FR" smtClean="0"/>
              <a:t>15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B116C-CEBA-4659-B1C5-A966FD5EDD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38807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50DAB9-A680-476A-AF99-ED613F95F723}" type="datetimeFigureOut">
              <a:rPr lang="fr-FR" smtClean="0"/>
              <a:t>15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BB116C-CEBA-4659-B1C5-A966FD5EDD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56726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42" b="9540"/>
          <a:stretch/>
        </p:blipFill>
        <p:spPr bwMode="auto">
          <a:xfrm>
            <a:off x="450374" y="1747349"/>
            <a:ext cx="3959974" cy="38954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67" r="1" b="8525"/>
          <a:stretch/>
        </p:blipFill>
        <p:spPr bwMode="auto">
          <a:xfrm>
            <a:off x="5021271" y="1747349"/>
            <a:ext cx="3958869" cy="39391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ZoneTexte 5"/>
          <p:cNvSpPr txBox="1"/>
          <p:nvPr/>
        </p:nvSpPr>
        <p:spPr>
          <a:xfrm>
            <a:off x="2722728" y="900761"/>
            <a:ext cx="3698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  <a:endParaRPr lang="fr-F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ZoneTexte 9"/>
          <p:cNvSpPr txBox="1"/>
          <p:nvPr/>
        </p:nvSpPr>
        <p:spPr>
          <a:xfrm rot="16200000">
            <a:off x="-1398898" y="3698757"/>
            <a:ext cx="36985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arm </a:t>
            </a:r>
            <a:r>
              <a:rPr lang="fr-F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chemia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ime (min)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ZoneTexte 10"/>
          <p:cNvSpPr txBox="1"/>
          <p:nvPr/>
        </p:nvSpPr>
        <p:spPr>
          <a:xfrm rot="16200000">
            <a:off x="3109787" y="3698758"/>
            <a:ext cx="36985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arm and cold </a:t>
            </a:r>
            <a:r>
              <a:rPr lang="fr-F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chemia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5183624" y="5540865"/>
            <a:ext cx="36985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ngraftment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655090" y="5540865"/>
            <a:ext cx="36985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ngraftment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655087" y="1849484"/>
            <a:ext cx="1214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= 0.033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5227087" y="1849484"/>
            <a:ext cx="1214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358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ZoneTexte 15"/>
          <p:cNvSpPr txBox="1"/>
          <p:nvPr/>
        </p:nvSpPr>
        <p:spPr>
          <a:xfrm>
            <a:off x="143299" y="1454759"/>
            <a:ext cx="5117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fr-F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ZoneTexte 16"/>
          <p:cNvSpPr txBox="1"/>
          <p:nvPr/>
        </p:nvSpPr>
        <p:spPr>
          <a:xfrm>
            <a:off x="4673855" y="1454759"/>
            <a:ext cx="5117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fr-F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093598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</TotalTime>
  <Words>27</Words>
  <Application>Microsoft Office PowerPoint</Application>
  <PresentationFormat>Affichage à l'écran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ius</dc:creator>
  <cp:lastModifiedBy>Marius</cp:lastModifiedBy>
  <cp:revision>9</cp:revision>
  <dcterms:created xsi:type="dcterms:W3CDTF">2014-05-09T10:37:55Z</dcterms:created>
  <dcterms:modified xsi:type="dcterms:W3CDTF">2014-05-15T17:12:40Z</dcterms:modified>
</cp:coreProperties>
</file>